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media/image3.jpeg" ContentType="image/jpeg"/>
  <Override PartName="/ppt/media/image4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476EBB-34C8-46E1-A8BB-1C97B9C9C0C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904A39-B7BA-4560-8232-FEAEB99C284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5D027C-FD43-46AB-8D1C-BE5A091DFED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33FBCB-DD4F-4C4E-A654-70606EEF9F3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60014E-2C8B-474C-BA16-9D108837191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F4536F-BDF4-4CE6-8F79-E5C2CCA79D7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97F1EB-3C60-450B-A725-997F7E3D970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C1A7A6-A3A2-4809-8349-1C291447FBE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24CB6A-7B02-4DCF-957A-F6D5DC903DE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54D7D9-B83A-4A6F-AC48-FD8A79499C1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D447A1-5AD5-4BD5-A50B-042B0066900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CD2749F-778B-47B1-95E6-09961668420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31BBCC0-8D74-4F2D-8F6D-710EC1DF5CEA}" type="slidenum">
              <a:rPr b="0" lang="en-GB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22"/>
          <p:cNvSpPr/>
          <p:nvPr/>
        </p:nvSpPr>
        <p:spPr>
          <a:xfrm>
            <a:off x="1170000" y="2282760"/>
            <a:ext cx="684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ARP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TextBox 23"/>
          <p:cNvSpPr/>
          <p:nvPr/>
        </p:nvSpPr>
        <p:spPr>
          <a:xfrm>
            <a:off x="988920" y="4757760"/>
            <a:ext cx="865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l-GR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β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acti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TextBox 3"/>
          <p:cNvSpPr/>
          <p:nvPr/>
        </p:nvSpPr>
        <p:spPr>
          <a:xfrm rot="18867000">
            <a:off x="1775880" y="1347120"/>
            <a:ext cx="1538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ontrol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TextBox 3"/>
          <p:cNvSpPr/>
          <p:nvPr/>
        </p:nvSpPr>
        <p:spPr>
          <a:xfrm rot="18867000">
            <a:off x="2073240" y="1204200"/>
            <a:ext cx="1952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† 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toposide (25 µM, 24h)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TextBox 3"/>
          <p:cNvSpPr/>
          <p:nvPr/>
        </p:nvSpPr>
        <p:spPr>
          <a:xfrm rot="18867000">
            <a:off x="2453040" y="1244880"/>
            <a:ext cx="1825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RAIL (100 ng/ml, 4h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TextBox 3"/>
          <p:cNvSpPr/>
          <p:nvPr/>
        </p:nvSpPr>
        <p:spPr>
          <a:xfrm rot="18867000">
            <a:off x="2799000" y="1219680"/>
            <a:ext cx="1917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* Doxorubicin (400nM, 8h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TextBox 28"/>
          <p:cNvSpPr/>
          <p:nvPr/>
        </p:nvSpPr>
        <p:spPr>
          <a:xfrm>
            <a:off x="1011240" y="3357720"/>
            <a:ext cx="843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aspase-3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Straight Connector 29"/>
          <p:cNvSpPr/>
          <p:nvPr/>
        </p:nvSpPr>
        <p:spPr>
          <a:xfrm>
            <a:off x="3546360" y="2357280"/>
            <a:ext cx="7164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Straight Connector 30"/>
          <p:cNvSpPr/>
          <p:nvPr/>
        </p:nvSpPr>
        <p:spPr>
          <a:xfrm>
            <a:off x="3546360" y="2560680"/>
            <a:ext cx="7164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TextBox 31"/>
          <p:cNvSpPr/>
          <p:nvPr/>
        </p:nvSpPr>
        <p:spPr>
          <a:xfrm>
            <a:off x="3635280" y="3002040"/>
            <a:ext cx="1249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35 kD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TextBox 32"/>
          <p:cNvSpPr/>
          <p:nvPr/>
        </p:nvSpPr>
        <p:spPr>
          <a:xfrm>
            <a:off x="3635280" y="3549600"/>
            <a:ext cx="2617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7 kDa (Cleaved Caspase-3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Straight Connector 33"/>
          <p:cNvSpPr/>
          <p:nvPr/>
        </p:nvSpPr>
        <p:spPr>
          <a:xfrm>
            <a:off x="3546360" y="3141720"/>
            <a:ext cx="7164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TextBox 34"/>
          <p:cNvSpPr/>
          <p:nvPr/>
        </p:nvSpPr>
        <p:spPr>
          <a:xfrm>
            <a:off x="3635280" y="2165400"/>
            <a:ext cx="1249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16 kD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Straight Connector 35"/>
          <p:cNvSpPr/>
          <p:nvPr/>
        </p:nvSpPr>
        <p:spPr>
          <a:xfrm>
            <a:off x="3546360" y="3687840"/>
            <a:ext cx="7164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TextBox 36"/>
          <p:cNvSpPr/>
          <p:nvPr/>
        </p:nvSpPr>
        <p:spPr>
          <a:xfrm>
            <a:off x="3635280" y="2454120"/>
            <a:ext cx="2214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89 kDa (Cleaved PARP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TextBox 37"/>
          <p:cNvSpPr/>
          <p:nvPr/>
        </p:nvSpPr>
        <p:spPr>
          <a:xfrm>
            <a:off x="1908000" y="5392800"/>
            <a:ext cx="309564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† 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toposide conditions used in manuscrip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* sample from Figure 1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7" name="Picture 2" descr="C:\Users\ah415\Desktop\13_1_16 paprp test rebuttal\13_1_16 bactin.jpg"/>
          <p:cNvPicPr/>
          <p:nvPr/>
        </p:nvPicPr>
        <p:blipFill>
          <a:blip r:embed="rId1"/>
          <a:srcRect l="14228" t="51675" r="66583" b="39912"/>
          <a:stretch/>
        </p:blipFill>
        <p:spPr>
          <a:xfrm>
            <a:off x="1908000" y="4735440"/>
            <a:ext cx="1548000" cy="3492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58" name="Picture 3" descr="C:\Users\ah415\Desktop\13_1_16 paprp test rebuttal\13_1_16 pp53.jpg"/>
          <p:cNvPicPr/>
          <p:nvPr/>
        </p:nvPicPr>
        <p:blipFill>
          <a:blip r:embed="rId2"/>
          <a:srcRect l="70738" t="43580" r="9116" b="44363"/>
          <a:stretch/>
        </p:blipFill>
        <p:spPr>
          <a:xfrm>
            <a:off x="1908000" y="4195800"/>
            <a:ext cx="1548000" cy="4777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59" name="Rectangle 40"/>
          <p:cNvSpPr/>
          <p:nvPr/>
        </p:nvSpPr>
        <p:spPr>
          <a:xfrm>
            <a:off x="817200" y="4303800"/>
            <a:ext cx="1029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-p53 (Ser15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0" name="Picture 4" descr="C:\Users\ah415\Desktop\13_1_16 paprp test rebuttal\13_1_16 parp.jpg"/>
          <p:cNvPicPr/>
          <p:nvPr/>
        </p:nvPicPr>
        <p:blipFill>
          <a:blip r:embed="rId3"/>
          <a:srcRect l="14077" t="20543" r="66495" b="58939"/>
          <a:stretch/>
        </p:blipFill>
        <p:spPr>
          <a:xfrm>
            <a:off x="1901880" y="2060640"/>
            <a:ext cx="1554120" cy="8460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61" name="Picture 5" descr="C:\Users\ah415\Desktop\13_1_16 paprp test rebuttal\13_1_16 caspase 3.jpg"/>
          <p:cNvPicPr/>
          <p:nvPr/>
        </p:nvPicPr>
        <p:blipFill>
          <a:blip r:embed="rId4"/>
          <a:srcRect l="46273" t="58694" r="34790" b="13818"/>
          <a:stretch/>
        </p:blipFill>
        <p:spPr>
          <a:xfrm>
            <a:off x="1908000" y="2973240"/>
            <a:ext cx="1548000" cy="11559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62" name="TextBox 3411"/>
          <p:cNvSpPr/>
          <p:nvPr/>
        </p:nvSpPr>
        <p:spPr>
          <a:xfrm>
            <a:off x="0" y="1440"/>
            <a:ext cx="1989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Figure S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01-13T11:51:44Z</dcterms:created>
  <dc:creator>Adam Hall</dc:creator>
  <dc:description/>
  <dc:language>en-US</dc:language>
  <cp:lastModifiedBy>l.latha</cp:lastModifiedBy>
  <dcterms:modified xsi:type="dcterms:W3CDTF">2016-04-05T12:11:22Z</dcterms:modified>
  <cp:revision>9</cp:revision>
  <dc:subject/>
  <dc:title>PowerPoint Presentation</dc:title>
</cp:coreProperties>
</file>